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9"/>
  </p:notesMasterIdLst>
  <p:sldIdLst>
    <p:sldId id="280" r:id="rId2"/>
    <p:sldId id="315" r:id="rId3"/>
    <p:sldId id="286" r:id="rId4"/>
    <p:sldId id="289" r:id="rId5"/>
    <p:sldId id="318" r:id="rId6"/>
    <p:sldId id="304" r:id="rId7"/>
    <p:sldId id="29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97" userDrawn="1">
          <p15:clr>
            <a:srgbClr val="A4A3A4"/>
          </p15:clr>
        </p15:guide>
        <p15:guide id="2" pos="4498" userDrawn="1">
          <p15:clr>
            <a:srgbClr val="A4A3A4"/>
          </p15:clr>
        </p15:guide>
        <p15:guide id="3" orient="horz" userDrawn="1">
          <p15:clr>
            <a:srgbClr val="A4A3A4"/>
          </p15:clr>
        </p15:guide>
        <p15:guide id="4" orient="horz" pos="4320" userDrawn="1">
          <p15:clr>
            <a:srgbClr val="A4A3A4"/>
          </p15:clr>
        </p15:guide>
        <p15:guide id="5" userDrawn="1">
          <p15:clr>
            <a:srgbClr val="A4A3A4"/>
          </p15:clr>
        </p15:guide>
        <p15:guide id="6" pos="76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149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1549" y="424"/>
      </p:cViewPr>
      <p:guideLst>
        <p:guide orient="horz" pos="3997"/>
        <p:guide pos="4498"/>
        <p:guide orient="horz"/>
        <p:guide orient="horz" pos="4320"/>
        <p:guide/>
        <p:guide pos="76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her Darreh-Shori" userId="32fafa77-b306-41d5-8588-634e11fd7ee2" providerId="ADAL" clId="{2CA43DA9-5EFC-4914-BCA3-41052A137D2A}"/>
    <pc:docChg chg="delSld">
      <pc:chgData name="Taher Darreh-Shori" userId="32fafa77-b306-41d5-8588-634e11fd7ee2" providerId="ADAL" clId="{2CA43DA9-5EFC-4914-BCA3-41052A137D2A}" dt="2025-09-11T15:21:24.584" v="9" actId="47"/>
      <pc:docMkLst>
        <pc:docMk/>
      </pc:docMkLst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576009575" sldId="281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2948977280" sldId="282"/>
        </pc:sldMkLst>
      </pc:sldChg>
      <pc:sldChg chg="del">
        <pc:chgData name="Taher Darreh-Shori" userId="32fafa77-b306-41d5-8588-634e11fd7ee2" providerId="ADAL" clId="{2CA43DA9-5EFC-4914-BCA3-41052A137D2A}" dt="2025-09-11T15:20:59.511" v="2" actId="47"/>
        <pc:sldMkLst>
          <pc:docMk/>
          <pc:sldMk cId="921210767" sldId="283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442152994" sldId="285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218550422" sldId="287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3192931058" sldId="288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253495080" sldId="290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340876528" sldId="291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3592440373" sldId="293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584339703" sldId="295"/>
        </pc:sldMkLst>
      </pc:sldChg>
      <pc:sldChg chg="del">
        <pc:chgData name="Taher Darreh-Shori" userId="32fafa77-b306-41d5-8588-634e11fd7ee2" providerId="ADAL" clId="{2CA43DA9-5EFC-4914-BCA3-41052A137D2A}" dt="2025-09-11T15:21:06.655" v="5" actId="47"/>
        <pc:sldMkLst>
          <pc:docMk/>
          <pc:sldMk cId="3197958774" sldId="296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790044938" sldId="297"/>
        </pc:sldMkLst>
      </pc:sldChg>
      <pc:sldChg chg="del">
        <pc:chgData name="Taher Darreh-Shori" userId="32fafa77-b306-41d5-8588-634e11fd7ee2" providerId="ADAL" clId="{2CA43DA9-5EFC-4914-BCA3-41052A137D2A}" dt="2025-09-11T15:21:09.139" v="7" actId="47"/>
        <pc:sldMkLst>
          <pc:docMk/>
          <pc:sldMk cId="2150345420" sldId="298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3165959387" sldId="299"/>
        </pc:sldMkLst>
      </pc:sldChg>
      <pc:sldChg chg="del">
        <pc:chgData name="Taher Darreh-Shori" userId="32fafa77-b306-41d5-8588-634e11fd7ee2" providerId="ADAL" clId="{2CA43DA9-5EFC-4914-BCA3-41052A137D2A}" dt="2025-09-11T15:20:56.767" v="0" actId="47"/>
        <pc:sldMkLst>
          <pc:docMk/>
          <pc:sldMk cId="91054123" sldId="300"/>
        </pc:sldMkLst>
      </pc:sldChg>
      <pc:sldChg chg="del">
        <pc:chgData name="Taher Darreh-Shori" userId="32fafa77-b306-41d5-8588-634e11fd7ee2" providerId="ADAL" clId="{2CA43DA9-5EFC-4914-BCA3-41052A137D2A}" dt="2025-09-11T15:20:58.121" v="1" actId="47"/>
        <pc:sldMkLst>
          <pc:docMk/>
          <pc:sldMk cId="870646252" sldId="301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362055486" sldId="302"/>
        </pc:sldMkLst>
      </pc:sldChg>
      <pc:sldChg chg="del">
        <pc:chgData name="Taher Darreh-Shori" userId="32fafa77-b306-41d5-8588-634e11fd7ee2" providerId="ADAL" clId="{2CA43DA9-5EFC-4914-BCA3-41052A137D2A}" dt="2025-09-11T15:21:01.500" v="3" actId="47"/>
        <pc:sldMkLst>
          <pc:docMk/>
          <pc:sldMk cId="2769469599" sldId="303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846672559" sldId="305"/>
        </pc:sldMkLst>
      </pc:sldChg>
      <pc:sldChg chg="del">
        <pc:chgData name="Taher Darreh-Shori" userId="32fafa77-b306-41d5-8588-634e11fd7ee2" providerId="ADAL" clId="{2CA43DA9-5EFC-4914-BCA3-41052A137D2A}" dt="2025-09-11T15:21:05.140" v="4" actId="47"/>
        <pc:sldMkLst>
          <pc:docMk/>
          <pc:sldMk cId="3240485530" sldId="306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3794575751" sldId="307"/>
        </pc:sldMkLst>
      </pc:sldChg>
      <pc:sldChg chg="del">
        <pc:chgData name="Taher Darreh-Shori" userId="32fafa77-b306-41d5-8588-634e11fd7ee2" providerId="ADAL" clId="{2CA43DA9-5EFC-4914-BCA3-41052A137D2A}" dt="2025-09-11T15:21:07.754" v="6" actId="47"/>
        <pc:sldMkLst>
          <pc:docMk/>
          <pc:sldMk cId="458031942" sldId="308"/>
        </pc:sldMkLst>
      </pc:sldChg>
      <pc:sldChg chg="del">
        <pc:chgData name="Taher Darreh-Shori" userId="32fafa77-b306-41d5-8588-634e11fd7ee2" providerId="ADAL" clId="{2CA43DA9-5EFC-4914-BCA3-41052A137D2A}" dt="2025-09-11T15:21:19.991" v="8" actId="47"/>
        <pc:sldMkLst>
          <pc:docMk/>
          <pc:sldMk cId="1192632351" sldId="309"/>
        </pc:sldMkLst>
      </pc:sldChg>
      <pc:sldChg chg="del">
        <pc:chgData name="Taher Darreh-Shori" userId="32fafa77-b306-41d5-8588-634e11fd7ee2" providerId="ADAL" clId="{2CA43DA9-5EFC-4914-BCA3-41052A137D2A}" dt="2025-09-11T15:21:24.584" v="9" actId="47"/>
        <pc:sldMkLst>
          <pc:docMk/>
          <pc:sldMk cId="3594270373" sldId="31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7C1330-CE84-42D4-B377-5AD86DD7B0EB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1EC712-F461-462A-88C3-EC7AFB192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4218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1EC712-F461-462A-88C3-EC7AFB19294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9448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81FCC-ECD9-076A-AFED-23EBC57497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301DB8-2A36-35D9-8515-CF43B1CB29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B5C9E-8C63-8C41-D9CF-6554698AA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33C7FA-E6CC-3F6C-EE5A-CC5C80BC0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105AD9-4DAC-F906-6241-B82BF9D87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786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2AF76-BC0B-40EE-7336-04D41655DC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9FDC97-0151-B796-76EA-2CF3A81A41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634C13-D63D-0341-97E7-5C43D57E4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410E5E-4736-2A6D-CED4-084E8DA8F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89C7A-8434-0D05-AA21-81A291D4A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79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5D708A-F9E1-26B0-3A43-9C2FF79192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F8131E-2E1A-C770-8269-E6512F60E5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FA1C2-3E38-2596-33F0-14BC24FA3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8DF99-427A-72D4-510B-688ED344F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769014-E1F1-06C8-F7DC-F1ED62E1E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BC70F-D845-FD56-18E3-BA6B24E141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A177BB-4FF8-973E-8E07-E2AE8B07B0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86A6D-BABD-F5C6-73B4-C19A06081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48078B-63D9-1F92-9DFB-489F5D9C6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D1C51-3FF7-CE5B-CC0A-EB620D4CD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018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F5FA0-B07D-2890-10A9-E05C65603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3C5BB9-8ED4-3B6E-BB61-BC35144F17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B7035E-2630-6BF8-A45E-AD650909F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9C1EC-7F20-78F6-5044-B53162AFB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6B194-F3B7-A61F-7A8D-26C88FC0B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052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6C22A-AA9D-54F3-B1D9-A722936F04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C9F17B-F8BA-BB22-E173-92C7704294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34A8D7-FFBC-B718-60A5-A6FA6FE59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E0524D-7C31-352D-2EBD-13F854B62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0C102F-C024-02FC-7503-056784562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01A10D-3E2D-D559-A7B0-AF74C5483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58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CF78D-C59C-FEA5-4061-4E4872376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53A66A-A177-5D0C-9E66-450D4DB430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68E432-16C7-92B8-8BB8-B5A130A175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408303-A31E-3A02-B363-6B715DE120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1EBE4B-1FFA-4587-751F-4262D638C5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EBE2A6-07B8-E4E4-A30B-C7969B00D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0D5990-1E68-82E0-DD24-F0E25AB9E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AB8105-0921-342F-31F1-72E00F51A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504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31343-514B-F823-9C3D-601048F7D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43801A-2AFC-B0B5-CBD0-02D9C7AD0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5329A8-8A90-F9B8-97FE-31BA2FA5C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A3AB40-9086-EEF3-DCE5-FF5BDDA49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528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3972BC-0C66-0B4E-657F-61C3F27CA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704CC7-E25F-3E62-D928-42E40C84F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577F35-2062-1E74-36A2-608F1BF10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882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15A62B-C1DD-2C9B-865F-83838D04E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ED519F-A508-2803-4BD4-8BD5967C3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A649DE-6E2C-6F11-714C-2EA9D13F0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9A13F1-0EA2-8EF8-CA24-5B5444828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EAF75A-68B2-D898-8F0F-3A3EBDD48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43D79A-61B0-EDAF-C62B-0E3FB76E8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629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37BD3-A3CF-459F-C390-CB4F44B05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2C2F3B-C06E-9BD4-05D6-1F2C9CA893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E7D4E0-9FA1-548F-A074-22F6AE2677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8A7518-9676-C3BA-939B-7E26ACF67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8D38DD-2FEA-6DB6-F0DA-2E98FC1D8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62E85C-207C-F5A8-3CB2-DA436E4A8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4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F6065-7BDB-F3BD-E0B3-8F85C78DB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67D1B6-62DA-4C5A-B8EC-A7E0A6EB85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F445EA-CBBB-9B5B-349B-C2CB6928F5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6157D4-CCA1-4D8F-ADC1-F01258DFC7DD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7A61E-4916-749E-D1BD-7A9B15A8BC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9904CD-DE81-82A0-6846-7A75A942F6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2916F7-B5F7-44FB-ACE9-7FA1D4C018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480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2.png"/><Relationship Id="rId4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6.MP4"/><Relationship Id="rId1" Type="http://schemas.microsoft.com/office/2007/relationships/media" Target="../media/media6.MP4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8244B505-A6B6-F198-C915-D0E5B84493A8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22636" y="0"/>
            <a:ext cx="11744007" cy="48320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ticle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ative Analysis of Cholinergic Machinery in Carcinomas: Discovery of Membrane-Tethered ChAT as Evidence for Surface-Based ACh Synthesis in Neuroblastoma Cells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nita Thakur *</a:t>
            </a:r>
            <a:r>
              <a:rPr kumimoji="0" lang="en-US" altLang="en-US" sz="2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amar Tarazi *</a:t>
            </a:r>
            <a:r>
              <a:rPr kumimoji="0" lang="en-US" altLang="en-US" sz="2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Lada Doležalová </a:t>
            </a:r>
            <a:r>
              <a:rPr kumimoji="0" lang="en-US" altLang="en-US" sz="2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omira Behbahani </a:t>
            </a:r>
            <a:r>
              <a:rPr kumimoji="0" lang="en-US" altLang="en-US" sz="2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aher Darreh-Shori </a:t>
            </a:r>
            <a:r>
              <a:rPr kumimoji="0" lang="en-US" altLang="en-US" sz="2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Neurobiology, Care Sciences and Society; Division of Clinical Geriatrics, Center for Alzheimer Research. Karolinska Institutet, S</a:t>
            </a:r>
            <a:r>
              <a:rPr kumimoji="0" lang="en-US" altLang="en-US" sz="16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ckholm,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weden. 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ence: taher.darreh-shori@ki.se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4556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_ST21.Dec.2023-afterFixOne-RandDChATand MitoRed-ice-60x-3009 - Reconstructednd2">
            <a:hlinkClick r:id="" action="ppaction://media"/>
            <a:extLst>
              <a:ext uri="{FF2B5EF4-FFF2-40B4-BE49-F238E27FC236}">
                <a16:creationId xmlns:a16="http://schemas.microsoft.com/office/drawing/2014/main" id="{7C6E375A-48EB-940C-4682-330F55E1FC95}"/>
              </a:ext>
            </a:extLst>
          </p:cNvPr>
          <p:cNvPicPr>
            <a:picLocks noGrp="1" noChangeAspect="1"/>
          </p:cNvPicPr>
          <p:nvPr>
            <p:ph idx="4294967295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35000" contrast="50000"/>
          </a:blip>
          <a:srcRect t="14432" b="2091"/>
          <a:stretch>
            <a:fillRect/>
          </a:stretch>
        </p:blipFill>
        <p:spPr>
          <a:xfrm>
            <a:off x="-1" y="0"/>
            <a:ext cx="12189891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8F578B5-A170-08AB-87AC-4715094994C5}"/>
              </a:ext>
            </a:extLst>
          </p:cNvPr>
          <p:cNvSpPr txBox="1"/>
          <p:nvPr/>
        </p:nvSpPr>
        <p:spPr>
          <a:xfrm>
            <a:off x="-2" y="-389820"/>
            <a:ext cx="12189891" cy="398585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2500" lnSpcReduction="20000"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400" dirty="0"/>
              <a:t>3D Videos and Images of </a:t>
            </a:r>
            <a:r>
              <a:rPr lang="en-US" sz="2800" b="1" dirty="0"/>
              <a:t>Surface ChAT </a:t>
            </a:r>
            <a:r>
              <a:rPr lang="en-US" sz="2400" dirty="0"/>
              <a:t>staining  (R&amp;D anti-ChAT Ab)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5A5D0A7-F83C-5FCA-BF73-3E363FC10E97}"/>
              </a:ext>
            </a:extLst>
          </p:cNvPr>
          <p:cNvGrpSpPr/>
          <p:nvPr/>
        </p:nvGrpSpPr>
        <p:grpSpPr>
          <a:xfrm>
            <a:off x="-50986" y="87088"/>
            <a:ext cx="12237939" cy="6774703"/>
            <a:chOff x="-50986" y="87088"/>
            <a:chExt cx="12237939" cy="6774703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DE4EC7DA-054E-8CD8-ED1C-78F31BD294EF}"/>
                </a:ext>
              </a:extLst>
            </p:cNvPr>
            <p:cNvGrpSpPr/>
            <p:nvPr/>
          </p:nvGrpSpPr>
          <p:grpSpPr>
            <a:xfrm>
              <a:off x="-50986" y="87088"/>
              <a:ext cx="7191561" cy="6537944"/>
              <a:chOff x="-50986" y="87088"/>
              <a:chExt cx="7191561" cy="6537944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94547F0-E887-1C99-6D14-F911F516965B}"/>
                  </a:ext>
                </a:extLst>
              </p:cNvPr>
              <p:cNvSpPr txBox="1"/>
              <p:nvPr/>
            </p:nvSpPr>
            <p:spPr>
              <a:xfrm>
                <a:off x="143122" y="87088"/>
                <a:ext cx="3609893" cy="35702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800" b="1" kern="1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3D Video 1:</a:t>
                </a:r>
                <a:r>
                  <a:rPr lang="en-US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epresentative 3D super-resolution immunofluorescence images of</a:t>
                </a:r>
                <a:endPara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ChAT </a:t>
                </a:r>
              </a:p>
              <a:p>
                <a:r>
                  <a:rPr lang="en-US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surface staining) in SH-SY5Y neuroblastoma cells.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hAT 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b="1" i="1" kern="1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&amp;D System </a:t>
                </a:r>
                <a:r>
                  <a:rPr lang="en-US" sz="1400" b="1" i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nti-ChAT Ab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</a:t>
                </a:r>
                <a:endPara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FF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chondria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kern="100" dirty="0" err="1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tracker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Red)</a:t>
                </a:r>
                <a:endPara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3149F7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ucleus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DAPI)</a:t>
                </a:r>
                <a:endParaRPr lang="en-US" sz="14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A19926A-64BC-8AC4-89FB-EF7085CF3BB1}"/>
                  </a:ext>
                </a:extLst>
              </p:cNvPr>
              <p:cNvSpPr txBox="1"/>
              <p:nvPr/>
            </p:nvSpPr>
            <p:spPr>
              <a:xfrm>
                <a:off x="-50986" y="6101812"/>
                <a:ext cx="7191561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immunostaining was performed on ice following cell fixation, without permeabilization, to target only the surface-exposed epitopes. </a:t>
                </a:r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80744D0-4B66-0EB0-D1DF-D021EB151835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727515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16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5" name="Rectangle 14">
            <a:extLst>
              <a:ext uri="{FF2B5EF4-FFF2-40B4-BE49-F238E27FC236}">
                <a16:creationId xmlns:a16="http://schemas.microsoft.com/office/drawing/2014/main" id="{2B97F24A-32CE-4C1C-A50D-3016B394DCF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ketch line">
            <a:extLst>
              <a:ext uri="{FF2B5EF4-FFF2-40B4-BE49-F238E27FC236}">
                <a16:creationId xmlns:a16="http://schemas.microsoft.com/office/drawing/2014/main" id="{CD8B4F24-440B-49E9-B85D-733523DC064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2573756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MO436C~1">
            <a:hlinkClick r:id="" action="ppaction://media"/>
            <a:extLst>
              <a:ext uri="{FF2B5EF4-FFF2-40B4-BE49-F238E27FC236}">
                <a16:creationId xmlns:a16="http://schemas.microsoft.com/office/drawing/2014/main" id="{0710193C-21BA-9B82-3FD2-6462B039E7E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>
            <a:lum bright="35000" contrast="50000"/>
          </a:blip>
          <a:stretch>
            <a:fillRect/>
          </a:stretch>
        </p:blipFill>
        <p:spPr>
          <a:xfrm>
            <a:off x="4599" y="1"/>
            <a:ext cx="12182353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4C78851-4CB2-B60C-1531-E4404277FF76}"/>
              </a:ext>
            </a:extLst>
          </p:cNvPr>
          <p:cNvSpPr txBox="1"/>
          <p:nvPr/>
        </p:nvSpPr>
        <p:spPr>
          <a:xfrm>
            <a:off x="143122" y="-403399"/>
            <a:ext cx="12189891" cy="398585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2500" lnSpcReduction="20000"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400" dirty="0"/>
              <a:t>3D Videos and Images of </a:t>
            </a:r>
            <a:r>
              <a:rPr lang="en-US" sz="2800" b="1" dirty="0"/>
              <a:t>Whole-cell ChAT </a:t>
            </a:r>
            <a:r>
              <a:rPr lang="en-US" sz="2400" dirty="0"/>
              <a:t>staining  (R&amp;D anti-ChAT Ab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04D0823-483A-9AA4-0B38-19B506AFC335}"/>
              </a:ext>
            </a:extLst>
          </p:cNvPr>
          <p:cNvGrpSpPr/>
          <p:nvPr/>
        </p:nvGrpSpPr>
        <p:grpSpPr>
          <a:xfrm>
            <a:off x="-19182" y="87088"/>
            <a:ext cx="12206135" cy="6774703"/>
            <a:chOff x="-19182" y="87088"/>
            <a:chExt cx="12206135" cy="677470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572F8AE-0C10-37F3-4DD5-E099016C7EC9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38794DA-5FF5-562E-650D-40A98240A28A}"/>
                </a:ext>
              </a:extLst>
            </p:cNvPr>
            <p:cNvSpPr txBox="1"/>
            <p:nvPr/>
          </p:nvSpPr>
          <p:spPr>
            <a:xfrm>
              <a:off x="143122" y="87088"/>
              <a:ext cx="3641699" cy="34778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kern="1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3D Video 2</a:t>
              </a:r>
              <a:r>
                <a: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: 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presentative 3D super-resolution immunofluorescence images of</a:t>
              </a:r>
              <a:endParaRPr lang="en-US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tra- &amp; Intra-cellular ChAT </a:t>
              </a:r>
              <a:r>
                <a:rPr lang="en-US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whole-cell staining) in SH-SY5Y neuroblastoma cells.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hAT 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b="1" i="1" kern="100" dirty="0">
                  <a:solidFill>
                    <a:srgbClr val="FFC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&amp;D System </a:t>
              </a:r>
              <a:r>
                <a:rPr lang="en-US" sz="1400" b="1" i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ti-ChAT Ab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en-US" sz="2000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chondria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tracker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Red)</a:t>
              </a:r>
              <a:endParaRPr lang="en-US" sz="2000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ucleus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DAPI)</a:t>
              </a:r>
              <a:endParaRPr lang="en-US" sz="1400" b="1" kern="100" dirty="0">
                <a:solidFill>
                  <a:srgbClr val="3149F7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ED0096C-A090-1523-B424-4D6D5377CD76}"/>
                </a:ext>
              </a:extLst>
            </p:cNvPr>
            <p:cNvSpPr txBox="1"/>
            <p:nvPr/>
          </p:nvSpPr>
          <p:spPr>
            <a:xfrm>
              <a:off x="-19182" y="6093862"/>
              <a:ext cx="7143551" cy="7386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 were first fixed and 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mmunostained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without permeabilization to label extracellular epitopes. Then the cells were subjected to a second fixation, which was followed by permeabilization to allow access to intracellular targets and re-incubated with the same antibodies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79963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74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OVIE_~2">
            <a:hlinkClick r:id="" action="ppaction://media"/>
            <a:extLst>
              <a:ext uri="{FF2B5EF4-FFF2-40B4-BE49-F238E27FC236}">
                <a16:creationId xmlns:a16="http://schemas.microsoft.com/office/drawing/2014/main" id="{915C0221-A7D9-3C38-81DD-9B85A87AC19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40000" contrast="50000"/>
          </a:blip>
          <a:srcRect l="16733" b="16678"/>
          <a:stretch>
            <a:fillRect/>
          </a:stretch>
        </p:blipFill>
        <p:spPr>
          <a:xfrm>
            <a:off x="-1" y="5"/>
            <a:ext cx="12183975" cy="68579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BB26636-038C-7832-A949-901902151B6D}"/>
              </a:ext>
            </a:extLst>
          </p:cNvPr>
          <p:cNvSpPr txBox="1"/>
          <p:nvPr/>
        </p:nvSpPr>
        <p:spPr>
          <a:xfrm>
            <a:off x="2239107" y="-532737"/>
            <a:ext cx="7532077" cy="522146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dirty="0"/>
              <a:t>3D Videos and Images of Surface BChE 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800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E651945-2787-EE5D-67B7-E4BC48376208}"/>
              </a:ext>
            </a:extLst>
          </p:cNvPr>
          <p:cNvGrpSpPr/>
          <p:nvPr/>
        </p:nvGrpSpPr>
        <p:grpSpPr>
          <a:xfrm>
            <a:off x="-50986" y="87088"/>
            <a:ext cx="12237939" cy="6774703"/>
            <a:chOff x="-50986" y="87088"/>
            <a:chExt cx="12237939" cy="6774703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68B0992-4AFC-921B-266A-031F4DDC19C5}"/>
                </a:ext>
              </a:extLst>
            </p:cNvPr>
            <p:cNvGrpSpPr/>
            <p:nvPr/>
          </p:nvGrpSpPr>
          <p:grpSpPr>
            <a:xfrm>
              <a:off x="-50986" y="87088"/>
              <a:ext cx="7191561" cy="6537944"/>
              <a:chOff x="-50986" y="87088"/>
              <a:chExt cx="7191561" cy="6537944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FE1B8D0-075D-D72A-A4CE-C410AD6DC41C}"/>
                  </a:ext>
                </a:extLst>
              </p:cNvPr>
              <p:cNvSpPr txBox="1"/>
              <p:nvPr/>
            </p:nvSpPr>
            <p:spPr>
              <a:xfrm>
                <a:off x="143122" y="87088"/>
                <a:ext cx="3609893" cy="35702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800" b="1" kern="1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3D Video </a:t>
                </a:r>
                <a:r>
                  <a:rPr lang="en-US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3</a:t>
                </a:r>
                <a:r>
                  <a:rPr lang="en-US" sz="1800" b="1" kern="1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:</a:t>
                </a:r>
                <a:r>
                  <a:rPr lang="en-US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epresentative 3D super-resolution immunofluorescence images of</a:t>
                </a:r>
                <a:endPara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BChE </a:t>
                </a:r>
              </a:p>
              <a:p>
                <a:r>
                  <a:rPr lang="en-US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surface staining) in SH-SY5Y neuroblastoma cells.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BChE 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b="1" i="1" kern="100" dirty="0" err="1">
                    <a:solidFill>
                      <a:srgbClr val="FFC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antaCruz</a:t>
                </a:r>
                <a:r>
                  <a:rPr lang="en-US" sz="1400" b="1" i="1" kern="1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b="1" i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nti-BChE Ab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</a:t>
                </a:r>
                <a:endPara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FF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chondria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kern="100" dirty="0" err="1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tracker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Red)</a:t>
                </a:r>
                <a:endPara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3149F7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ucleus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DAPI)</a:t>
                </a:r>
                <a:endParaRPr lang="en-US" sz="14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019200A-A949-2B22-E9FD-956FAFCDCF20}"/>
                  </a:ext>
                </a:extLst>
              </p:cNvPr>
              <p:cNvSpPr txBox="1"/>
              <p:nvPr/>
            </p:nvSpPr>
            <p:spPr>
              <a:xfrm>
                <a:off x="-50986" y="6101812"/>
                <a:ext cx="7191561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immunostaining was performed on ice following cell fixation, without permeabilization, to target only the surface-exposed epitopes. 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A0C18BB-5C9A-92FF-604E-11A35A2CA748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52753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74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BB26636-038C-7832-A949-901902151B6D}"/>
              </a:ext>
            </a:extLst>
          </p:cNvPr>
          <p:cNvSpPr txBox="1"/>
          <p:nvPr/>
        </p:nvSpPr>
        <p:spPr>
          <a:xfrm>
            <a:off x="630936" y="2842377"/>
            <a:ext cx="3429000" cy="341071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indent="-228600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200" b="1" dirty="0"/>
              <a:t>3D Videos and Images of Whole cell BChE 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200" b="1" dirty="0"/>
          </a:p>
        </p:txBody>
      </p:sp>
      <p:pic>
        <p:nvPicPr>
          <p:cNvPr id="4" name="MOVIE_~4">
            <a:hlinkClick r:id="" action="ppaction://media"/>
            <a:extLst>
              <a:ext uri="{FF2B5EF4-FFF2-40B4-BE49-F238E27FC236}">
                <a16:creationId xmlns:a16="http://schemas.microsoft.com/office/drawing/2014/main" id="{8C9AE1FC-4432-848F-B7D7-64D46CBA2AF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40000" contrast="50000"/>
          </a:blip>
          <a:stretch>
            <a:fillRect/>
          </a:stretch>
        </p:blipFill>
        <p:spPr>
          <a:xfrm>
            <a:off x="0" y="0"/>
            <a:ext cx="12254671" cy="689325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9FACDC5-6854-57E5-6BA4-8DEC9D31B0A0}"/>
              </a:ext>
            </a:extLst>
          </p:cNvPr>
          <p:cNvSpPr txBox="1"/>
          <p:nvPr/>
        </p:nvSpPr>
        <p:spPr>
          <a:xfrm>
            <a:off x="2239107" y="-516836"/>
            <a:ext cx="7532077" cy="522146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85000" lnSpcReduction="10000"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dirty="0"/>
              <a:t>3D Videos and Images of Whole-cell BChE 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800" b="1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5778FF1-4D6E-5DC4-35F4-E1EB535312A4}"/>
              </a:ext>
            </a:extLst>
          </p:cNvPr>
          <p:cNvGrpSpPr/>
          <p:nvPr/>
        </p:nvGrpSpPr>
        <p:grpSpPr>
          <a:xfrm>
            <a:off x="-19182" y="87088"/>
            <a:ext cx="12206135" cy="6774703"/>
            <a:chOff x="-19182" y="87088"/>
            <a:chExt cx="12206135" cy="677470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106C706-D99F-1F46-5906-F3136D318A1B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E3C69B-3261-911D-BBCF-91A43DEA255B}"/>
                </a:ext>
              </a:extLst>
            </p:cNvPr>
            <p:cNvSpPr txBox="1"/>
            <p:nvPr/>
          </p:nvSpPr>
          <p:spPr>
            <a:xfrm>
              <a:off x="143122" y="87088"/>
              <a:ext cx="3641699" cy="34778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kern="1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3D Video 4</a:t>
              </a:r>
              <a:r>
                <a: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: 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presentative 3D super-resolution immunofluorescence images of</a:t>
              </a:r>
              <a:endParaRPr lang="en-US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tra- &amp; Intra-cellular BChE </a:t>
              </a:r>
              <a:r>
                <a:rPr lang="en-US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whole-cell staining) in SH-SY5Y neuroblastoma cells.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ChE 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b="1" i="1" kern="100" dirty="0" err="1">
                  <a:solidFill>
                    <a:srgbClr val="FFC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antaCruz</a:t>
              </a:r>
              <a:r>
                <a:rPr lang="en-US" sz="1400" b="1" i="1" kern="100" dirty="0">
                  <a:solidFill>
                    <a:srgbClr val="FFC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b="1" i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ti-BChE Ab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en-US" sz="2000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chondria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tracker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Red)</a:t>
              </a:r>
              <a:endParaRPr lang="en-US" sz="2000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ucleus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DAPI)</a:t>
              </a:r>
              <a:endParaRPr lang="en-US" sz="1400" b="1" kern="100" dirty="0">
                <a:solidFill>
                  <a:srgbClr val="3149F7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121DCB-0DF3-4217-CD09-66D30F54068D}"/>
                </a:ext>
              </a:extLst>
            </p:cNvPr>
            <p:cNvSpPr txBox="1"/>
            <p:nvPr/>
          </p:nvSpPr>
          <p:spPr>
            <a:xfrm>
              <a:off x="-19182" y="6093862"/>
              <a:ext cx="7143551" cy="7386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 were first fixed and 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mmunostained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without permeabilization to label extracellular epitopes. Then the cells were subjected to a second fixation, which was followed by permeabilization to allow access to intracellular targets and re-incubated with the same antibodies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66269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74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04349EF-A21C-B2B3-EEFB-ACFE9589F51A}"/>
              </a:ext>
            </a:extLst>
          </p:cNvPr>
          <p:cNvSpPr txBox="1"/>
          <p:nvPr/>
        </p:nvSpPr>
        <p:spPr>
          <a:xfrm>
            <a:off x="630936" y="2842377"/>
            <a:ext cx="3429000" cy="341071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indent="-228600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200" b="1" dirty="0"/>
              <a:t>3D Videos and Images of Surface AChE 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200" b="1" dirty="0"/>
          </a:p>
        </p:txBody>
      </p:sp>
      <p:pic>
        <p:nvPicPr>
          <p:cNvPr id="9" name="MOVIE_~1">
            <a:hlinkClick r:id="" action="ppaction://media"/>
            <a:extLst>
              <a:ext uri="{FF2B5EF4-FFF2-40B4-BE49-F238E27FC236}">
                <a16:creationId xmlns:a16="http://schemas.microsoft.com/office/drawing/2014/main" id="{987F4635-91B5-5BCD-6232-000DCE755C8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20000" contrast="30000"/>
          </a:blip>
          <a:stretch>
            <a:fillRect/>
          </a:stretch>
        </p:blipFill>
        <p:spPr>
          <a:xfrm>
            <a:off x="0" y="1"/>
            <a:ext cx="1219200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86FA7F-8B7C-EE33-5985-B8944CC0C107}"/>
              </a:ext>
            </a:extLst>
          </p:cNvPr>
          <p:cNvSpPr txBox="1"/>
          <p:nvPr/>
        </p:nvSpPr>
        <p:spPr>
          <a:xfrm>
            <a:off x="2239107" y="-516833"/>
            <a:ext cx="7532077" cy="522146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dirty="0"/>
              <a:t>3D Videos and Images of </a:t>
            </a:r>
            <a:r>
              <a:rPr lang="en-US" sz="2800" b="1" dirty="0"/>
              <a:t>Surface AChE </a:t>
            </a:r>
            <a:r>
              <a:rPr lang="en-US" sz="2800" dirty="0"/>
              <a:t>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800" b="1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7AEE502-3678-6C06-22F7-E6185817A385}"/>
              </a:ext>
            </a:extLst>
          </p:cNvPr>
          <p:cNvGrpSpPr/>
          <p:nvPr/>
        </p:nvGrpSpPr>
        <p:grpSpPr>
          <a:xfrm>
            <a:off x="-50986" y="87088"/>
            <a:ext cx="12237939" cy="6774703"/>
            <a:chOff x="-50986" y="87088"/>
            <a:chExt cx="12237939" cy="6774703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9E2820DA-4792-865C-348D-C786170537EF}"/>
                </a:ext>
              </a:extLst>
            </p:cNvPr>
            <p:cNvGrpSpPr/>
            <p:nvPr/>
          </p:nvGrpSpPr>
          <p:grpSpPr>
            <a:xfrm>
              <a:off x="-50986" y="87088"/>
              <a:ext cx="7191561" cy="6537944"/>
              <a:chOff x="-50986" y="87088"/>
              <a:chExt cx="7191561" cy="6537944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4375964-F203-5AC8-F7CA-838189D6CD82}"/>
                  </a:ext>
                </a:extLst>
              </p:cNvPr>
              <p:cNvSpPr txBox="1"/>
              <p:nvPr/>
            </p:nvSpPr>
            <p:spPr>
              <a:xfrm>
                <a:off x="143122" y="87088"/>
                <a:ext cx="3609893" cy="357020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800" b="1" kern="1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3D Video 5:</a:t>
                </a:r>
                <a:r>
                  <a:rPr lang="en-US" b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epresentative 3D super-resolution immunofluorescence images of</a:t>
                </a:r>
                <a:endPara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r>
                  <a:rPr lang="en-US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AChE </a:t>
                </a:r>
              </a:p>
              <a:p>
                <a:r>
                  <a:rPr lang="en-US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surface staining) in SH-SY5Y neuroblastoma cells. </a:t>
                </a: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00B05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hE 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b="1" i="1" kern="100" dirty="0" err="1">
                    <a:solidFill>
                      <a:srgbClr val="FFC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antaCruz</a:t>
                </a:r>
                <a:r>
                  <a:rPr lang="en-US" sz="1400" b="1" i="1" kern="100" dirty="0">
                    <a:solidFill>
                      <a:srgbClr val="FFC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</a:t>
                </a:r>
                <a:r>
                  <a:rPr lang="en-US" sz="1400" b="1" i="1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nti-AChE Ab</a:t>
                </a:r>
                <a:r>
                  <a:rPr lang="en-US" sz="14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</a:t>
                </a:r>
                <a:endPara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FF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chondria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</a:t>
                </a:r>
                <a:r>
                  <a:rPr lang="en-US" sz="1400" kern="100" dirty="0" err="1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totracker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Red)</a:t>
                </a:r>
                <a:endPara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2000" b="1" kern="100" dirty="0">
                    <a:solidFill>
                      <a:srgbClr val="3149F7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Nucleus </a:t>
                </a:r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DAPI)</a:t>
                </a:r>
                <a:endParaRPr lang="en-US" sz="14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endPara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2B7D858-CA92-662F-27DB-AE6C70A2212C}"/>
                  </a:ext>
                </a:extLst>
              </p:cNvPr>
              <p:cNvSpPr txBox="1"/>
              <p:nvPr/>
            </p:nvSpPr>
            <p:spPr>
              <a:xfrm>
                <a:off x="-50986" y="6101812"/>
                <a:ext cx="7191561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400" kern="100" dirty="0">
                    <a:solidFill>
                      <a:schemeClr val="bg1">
                        <a:lumMod val="95000"/>
                      </a:schemeClr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xtracellular immunostaining was performed on ice following cell fixation, without permeabilization, to target only the surface-exposed epitopes. 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1CD2EA1-DC9D-CBC2-715D-C38EA15B0EDB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008183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14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OVIE_~3">
            <a:hlinkClick r:id="" action="ppaction://media"/>
            <a:extLst>
              <a:ext uri="{FF2B5EF4-FFF2-40B4-BE49-F238E27FC236}">
                <a16:creationId xmlns:a16="http://schemas.microsoft.com/office/drawing/2014/main" id="{20C0B780-2EDC-11C3-7EED-CF77522C9B7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20000" contrast="30000"/>
          </a:blip>
          <a:srcRect b="18290"/>
          <a:stretch>
            <a:fillRect/>
          </a:stretch>
        </p:blipFill>
        <p:spPr>
          <a:xfrm>
            <a:off x="1" y="0"/>
            <a:ext cx="12239124" cy="685799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3AC1285-6694-A368-B347-98AD07F34554}"/>
              </a:ext>
            </a:extLst>
          </p:cNvPr>
          <p:cNvSpPr txBox="1"/>
          <p:nvPr/>
        </p:nvSpPr>
        <p:spPr>
          <a:xfrm>
            <a:off x="2239107" y="-508885"/>
            <a:ext cx="7532077" cy="522146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dirty="0"/>
              <a:t>3D Videos and Images of </a:t>
            </a:r>
            <a:r>
              <a:rPr lang="en-US" sz="2800" b="1" dirty="0"/>
              <a:t>Whole cell AChE </a:t>
            </a:r>
            <a:r>
              <a:rPr lang="en-US" sz="2800" dirty="0"/>
              <a:t>staining </a:t>
            </a:r>
          </a:p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endParaRPr lang="en-US" sz="2800" b="1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5778FF1-4D6E-5DC4-35F4-E1EB535312A4}"/>
              </a:ext>
            </a:extLst>
          </p:cNvPr>
          <p:cNvGrpSpPr/>
          <p:nvPr/>
        </p:nvGrpSpPr>
        <p:grpSpPr>
          <a:xfrm>
            <a:off x="-19182" y="87088"/>
            <a:ext cx="12206135" cy="6774703"/>
            <a:chOff x="-19182" y="87088"/>
            <a:chExt cx="12206135" cy="677470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106C706-D99F-1F46-5906-F3136D318A1B}"/>
                </a:ext>
              </a:extLst>
            </p:cNvPr>
            <p:cNvSpPr txBox="1"/>
            <p:nvPr/>
          </p:nvSpPr>
          <p:spPr>
            <a:xfrm>
              <a:off x="9955032" y="6262524"/>
              <a:ext cx="2231921" cy="5992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ges were acquired using 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epSIM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echnology (</a:t>
              </a:r>
              <a:r>
                <a:rPr lang="en-US" sz="1050" kern="100" dirty="0" err="1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estOptics</a:t>
              </a:r>
              <a:r>
                <a:rPr lang="en-US" sz="1050" kern="100" dirty="0">
                  <a:solidFill>
                    <a:schemeClr val="tx2">
                      <a:lumMod val="10000"/>
                      <a:lumOff val="90000"/>
                    </a:schemeClr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at 60× magnification. </a:t>
              </a:r>
              <a:endParaRPr lang="en-IN" sz="1050" kern="100" dirty="0">
                <a:solidFill>
                  <a:schemeClr val="tx2">
                    <a:lumMod val="10000"/>
                    <a:lumOff val="90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E3C69B-3261-911D-BBCF-91A43DEA255B}"/>
                </a:ext>
              </a:extLst>
            </p:cNvPr>
            <p:cNvSpPr txBox="1"/>
            <p:nvPr/>
          </p:nvSpPr>
          <p:spPr>
            <a:xfrm>
              <a:off x="143122" y="87088"/>
              <a:ext cx="3641699" cy="34778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b="1" kern="1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3D Video </a:t>
              </a:r>
              <a:r>
                <a:rPr lang="en-US" b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6: 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presentative 3D super-resolution immunofluorescence images of</a:t>
              </a:r>
              <a:endParaRPr lang="en-US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tra- &amp; Intra-cellular AChE </a:t>
              </a:r>
              <a:r>
                <a:rPr lang="en-US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whole-cell staining) in SH-SY5Y neuroblastoma cells. </a:t>
              </a: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00B05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hE 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b="1" i="1" kern="100" dirty="0" err="1">
                  <a:solidFill>
                    <a:srgbClr val="FFC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antaCruz</a:t>
              </a:r>
              <a:r>
                <a:rPr lang="en-US" sz="1400" b="1" i="1" kern="100" dirty="0">
                  <a:solidFill>
                    <a:srgbClr val="FFC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b="1" i="1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ti-AChE Ab</a:t>
              </a:r>
              <a:r>
                <a:rPr lang="en-US" sz="14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</a:t>
              </a:r>
              <a:endParaRPr lang="en-US" sz="2000" b="1" kern="100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chondria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totracker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Red)</a:t>
              </a:r>
              <a:endParaRPr lang="en-US" sz="2000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2000" b="1" kern="100" dirty="0">
                  <a:solidFill>
                    <a:srgbClr val="3149F7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ucleus 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DAPI)</a:t>
              </a:r>
              <a:endParaRPr lang="en-US" sz="1400" b="1" kern="100" dirty="0">
                <a:solidFill>
                  <a:srgbClr val="3149F7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endParaRPr lang="en-US" b="1" kern="1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121DCB-0DF3-4217-CD09-66D30F54068D}"/>
                </a:ext>
              </a:extLst>
            </p:cNvPr>
            <p:cNvSpPr txBox="1"/>
            <p:nvPr/>
          </p:nvSpPr>
          <p:spPr>
            <a:xfrm>
              <a:off x="-19182" y="6093862"/>
              <a:ext cx="7143551" cy="7386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 were first fixed and </a:t>
              </a:r>
              <a:r>
                <a:rPr lang="en-US" sz="1400" kern="100" dirty="0" err="1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mmunostained</a:t>
              </a:r>
              <a:r>
                <a:rPr lang="en-US" sz="1400" kern="100" dirty="0">
                  <a:solidFill>
                    <a:schemeClr val="bg1">
                      <a:lumMod val="95000"/>
                    </a:schemeClr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without permeabilization to label extracellular epitopes. Then the cells were subjected to a second fixation, which was followed by permeabilization to allow access to intracellular targets and re-incubated with the same antibodies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74650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34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1</TotalTime>
  <Words>661</Words>
  <Application>Microsoft Office PowerPoint</Application>
  <PresentationFormat>Widescreen</PresentationFormat>
  <Paragraphs>77</Paragraphs>
  <Slides>7</Slides>
  <Notes>1</Notes>
  <HiddenSlides>0</HiddenSlides>
  <MMClips>6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ptos Display</vt:lpstr>
      <vt:lpstr>Arial</vt:lpstr>
      <vt:lpstr>Palatino Linotype</vt:lpstr>
      <vt:lpstr>Times New Roman</vt:lpstr>
      <vt:lpstr>Office Theme</vt:lpstr>
      <vt:lpstr>Article Comparative Analysis of Cholinergic Machinery in Carcinomas: Discovery of Membrane-Tethered ChAT as Evidence for Surface-Based ACh Synthesis in Neuroblastoma Cells Banita Thakur *1, Samar Tarazi *1, Lada Doležalová 1, Homira Behbahani 1 and Taher Darreh-Shori 1 1Department of Neurobiology, Care Sciences and Society; Division of Clinical Geriatrics, Center for Alzheimer Research. Karolinska Institutet, Stockholm, Sweden.  *Correspondence: taher.darreh-shori@ki.s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her Darreh-Shori</dc:creator>
  <cp:lastModifiedBy>Taher Darreh-Shori</cp:lastModifiedBy>
  <cp:revision>2</cp:revision>
  <dcterms:created xsi:type="dcterms:W3CDTF">2025-09-01T12:01:40Z</dcterms:created>
  <dcterms:modified xsi:type="dcterms:W3CDTF">2025-09-11T15:21:24Z</dcterms:modified>
</cp:coreProperties>
</file>